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87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041BFE5-97CE-F5E6-29E5-1A1AB7FB8A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4AC00DD-9CCF-4273-49D4-403CBAFF43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AF3733-41CB-543A-35AD-48A48F6B9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2F318A3-C15F-F961-4B65-E217C585C0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489686-514D-8595-BEE4-76F9029F8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67299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B29D99-2BE9-09C7-BA5F-9A4A848279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E3CE296-D389-DAA6-0A8C-AEF6262CBF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14912B-8A64-001F-67E0-B5106250E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60F0560-910E-AB5B-B3A3-3D6877BC9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35A591-FED6-F6CD-28C9-9481E24A0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3140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5E71D1F-FDF6-831A-79DC-ECA54C5F81F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17127ED-9D10-4588-BCAC-DEAE8420CF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70FF91-A8CA-2448-7551-28B49362D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7991A2-D2C5-A868-6CC0-43F883ED1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DD9945-E489-BD29-F9DF-7F891E971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666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BD80502-6608-6007-1E5E-08F097BECB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227F248-E1C9-06A9-AF7E-8AFD2EE309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73DED19-B8FB-AB24-25C9-85933E79A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2F29DA-B7C8-6CD0-F8B8-88E5E08C9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0CE8C27-76F9-E82A-B4F8-173979926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5689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72CEB8-0BD1-37FF-6658-21CC1F4773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BC05F4-9524-7B49-AB88-1394BDD24B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5A2FC1-2898-E90E-6EBD-4089FA0D4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9798C6-16EE-4615-C34E-0AC228B2C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7BCAA55-9872-FE77-2D6F-B5D2859C65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08050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A57EEF-B6CC-186D-E224-92AEA3F1CF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F5BB123-9867-5E96-19CC-5B70907FF5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BB956CC-4123-ED27-E180-D75EAE5ED4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C7F7E14-B5D9-9234-48BE-C8C0E17DA6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FCA123C-06F8-FD67-7E45-DFADA4DA8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CF50C3-491D-4E82-E6D6-BEC150C25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83199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1670D8-A4A9-6D2A-0102-3837235968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1BE2843-419A-C7E8-4341-37355CC3BC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75931C6-FF3D-030D-458C-3AC99CCB21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8515712-C4EA-CB18-4AAB-072FEFB2EF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C359660-467A-F51D-625D-8906A97BC6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7123F62-5860-24E1-80F1-A2824CFBEC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9607CE5-3F09-2A0C-9E5F-541BB8A50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FBF6524F-7CDB-B313-B2B0-618117090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5005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40933C-7E94-EC33-E78E-E50A8CD80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648678C-7CB2-DD53-616A-409822252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0F4F433-526D-5DC6-6C4A-38BC4A8AA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03FD805-5F13-3794-9058-7A882AF80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2296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7DF6EC3-0831-87EF-E572-6EF6356A0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50E1DAF-0343-5E31-A25B-9F4785B15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F8DABEC-6E1A-111F-AC5A-1E6A06D59F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4423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E9A21F-ED83-05E0-DEA0-681EE0B751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9F2863-4A63-F389-266D-533E7FDECC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0C567DF-B9A7-F9E5-7600-BCC5EAB186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42CDE52-0794-96F7-310C-BE74808140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B3AB41-DBE5-F9D1-2196-BE10FA3F85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35299B2-30F5-0A51-4565-869640DE4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84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24147F-CFAF-822B-438D-D2007D000B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2D8EDE2E-247B-549F-E4D4-243DBC8C17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4179FD-9188-1FB6-853E-D89C9D4AAC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B056A37-FA18-31E7-0C06-EDE4F555CA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BABE473-457A-B0E4-A4EA-72BC0BD97D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57553AB-B775-0621-B72D-781D53543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64745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855C14C-EE8E-6E4F-2A37-E92672B4AD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6521D9-149F-DD2C-DD8F-720200DEF8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45478F3-4DC0-D5B4-B94F-9811DDB086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8A8699C-4D96-4E87-A0BC-23F724CBE244}" type="datetimeFigureOut">
              <a:rPr lang="zh-CN" altLang="en-US" smtClean="0"/>
              <a:t>2025/12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145D4F-C03D-6D33-C6D6-3B844CCE0F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F9A3EF-B924-58E7-F0BA-90B7D36F7EC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884789D-BE0C-4FF3-BFAC-5215F84AAC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11041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DCA80AC4-F297-3786-E4A2-D89BA9386897}"/>
              </a:ext>
            </a:extLst>
          </p:cNvPr>
          <p:cNvSpPr txBox="1"/>
          <p:nvPr/>
        </p:nvSpPr>
        <p:spPr>
          <a:xfrm>
            <a:off x="884027" y="5380962"/>
            <a:ext cx="996523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1</a:t>
            </a:r>
            <a:r>
              <a:rPr lang="en-US" altLang="zh-CN" sz="1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enotypic Analysis of Transgenic marigold overexpressing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ADS6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 different Inflorescence development stages. S3: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lorescence at the semi-open stage; S4: inflorescence at the fully-bloom stage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: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ld-type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. OE: OE-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MADS6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1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 descr="黄色的花&#10;&#10;AI 生成的内容可能不正确。">
            <a:extLst>
              <a:ext uri="{FF2B5EF4-FFF2-40B4-BE49-F238E27FC236}">
                <a16:creationId xmlns:a16="http://schemas.microsoft.com/office/drawing/2014/main" id="{5C1D5372-EE64-5A0C-95EB-84F1BD2C8C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6729" y="678451"/>
            <a:ext cx="4137709" cy="43481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2429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2E85AD08-B6F5-7F7F-E9B0-D1EAD5F8FE4C}"/>
              </a:ext>
            </a:extLst>
          </p:cNvPr>
          <p:cNvSpPr txBox="1"/>
          <p:nvPr/>
        </p:nvSpPr>
        <p:spPr>
          <a:xfrm>
            <a:off x="1026037" y="5925331"/>
            <a:ext cx="9965236" cy="8002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srgbClr val="0F1115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igure S2. </a:t>
            </a:r>
            <a:r>
              <a:rPr lang="en-US" altLang="zh-CN" sz="1400" dirty="0">
                <a:solidFill>
                  <a:srgbClr val="0F1115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alysis of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ormalized cluster and principal component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. (a)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eat-map of correlation analysis between samples; (b) Principal component analysis (PCA) between samples.</a:t>
            </a:r>
            <a:endParaRPr lang="zh-CN" altLang="zh-CN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3" name="图片 2" descr="图表&#10;&#10;AI 生成的内容可能不正确。">
            <a:extLst>
              <a:ext uri="{FF2B5EF4-FFF2-40B4-BE49-F238E27FC236}">
                <a16:creationId xmlns:a16="http://schemas.microsoft.com/office/drawing/2014/main" id="{B1955EB1-C111-0BDC-C5E8-B753F6C066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1375"/>
            <a:ext cx="9448800" cy="50958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43514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9</TotalTime>
  <Words>73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unling zhang</dc:creator>
  <cp:lastModifiedBy>chunling zhang</cp:lastModifiedBy>
  <cp:revision>21</cp:revision>
  <dcterms:created xsi:type="dcterms:W3CDTF">2025-09-16T13:32:38Z</dcterms:created>
  <dcterms:modified xsi:type="dcterms:W3CDTF">2025-12-03T09:47:14Z</dcterms:modified>
</cp:coreProperties>
</file>